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notesMasterIdLst>
    <p:notesMasterId r:id="rId7"/>
  </p:notesMasterIdLst>
  <p:sldIdLst>
    <p:sldId id="786" r:id="rId5"/>
    <p:sldId id="790" r:id="rId6"/>
  </p:sldIdLst>
  <p:sldSz cx="21674138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386" autoAdjust="0"/>
    <p:restoredTop sz="92959" autoAdjust="0"/>
  </p:normalViewPr>
  <p:slideViewPr>
    <p:cSldViewPr snapToGrid="0">
      <p:cViewPr>
        <p:scale>
          <a:sx n="79" d="100"/>
          <a:sy n="79" d="100"/>
        </p:scale>
        <p:origin x="2016" y="648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B083EC-3FB8-4BD7-A251-E9CA722EF5EF}" type="datetimeFigureOut">
              <a:rPr lang="en-US" smtClean="0"/>
              <a:t>1/1/26</a:t>
            </a:fld>
            <a:endParaRPr 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4ACC00-1F03-4A57-9016-3F732E325A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4435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09267" y="1995312"/>
            <a:ext cx="16255604" cy="4244622"/>
          </a:xfrm>
        </p:spPr>
        <p:txBody>
          <a:bodyPr anchor="b"/>
          <a:lstStyle>
            <a:lvl1pPr algn="ctr">
              <a:defRPr sz="10666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709267" y="6403623"/>
            <a:ext cx="16255604" cy="2943577"/>
          </a:xfrm>
        </p:spPr>
        <p:txBody>
          <a:bodyPr/>
          <a:lstStyle>
            <a:lvl1pPr marL="0" indent="0" algn="ctr">
              <a:buNone/>
              <a:defRPr sz="4266"/>
            </a:lvl1pPr>
            <a:lvl2pPr marL="812764" indent="0" algn="ctr">
              <a:buNone/>
              <a:defRPr sz="3555"/>
            </a:lvl2pPr>
            <a:lvl3pPr marL="1625529" indent="0" algn="ctr">
              <a:buNone/>
              <a:defRPr sz="3200"/>
            </a:lvl3pPr>
            <a:lvl4pPr marL="2438293" indent="0" algn="ctr">
              <a:buNone/>
              <a:defRPr sz="2844"/>
            </a:lvl4pPr>
            <a:lvl5pPr marL="3251058" indent="0" algn="ctr">
              <a:buNone/>
              <a:defRPr sz="2844"/>
            </a:lvl5pPr>
            <a:lvl6pPr marL="4063822" indent="0" algn="ctr">
              <a:buNone/>
              <a:defRPr sz="2844"/>
            </a:lvl6pPr>
            <a:lvl7pPr marL="4876587" indent="0" algn="ctr">
              <a:buNone/>
              <a:defRPr sz="2844"/>
            </a:lvl7pPr>
            <a:lvl8pPr marL="5689351" indent="0" algn="ctr">
              <a:buNone/>
              <a:defRPr sz="2844"/>
            </a:lvl8pPr>
            <a:lvl9pPr marL="6502116" indent="0" algn="ctr">
              <a:buNone/>
              <a:defRPr sz="2844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96160-37B1-4440-BB8A-D07BCDAEAA14}" type="datetimeFigureOut">
              <a:rPr lang="en-US" smtClean="0"/>
              <a:t>1/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0880-44C6-4194-8F38-8C5D571D1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608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96160-37B1-4440-BB8A-D07BCDAEAA14}" type="datetimeFigureOut">
              <a:rPr lang="en-US" smtClean="0"/>
              <a:t>1/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0880-44C6-4194-8F38-8C5D571D1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958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510555" y="649111"/>
            <a:ext cx="4673486" cy="1033215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90097" y="649111"/>
            <a:ext cx="13749531" cy="1033215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96160-37B1-4440-BB8A-D07BCDAEAA14}" type="datetimeFigureOut">
              <a:rPr lang="en-US" smtClean="0"/>
              <a:t>1/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0880-44C6-4194-8F38-8C5D571D1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895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96160-37B1-4440-BB8A-D07BCDAEAA14}" type="datetimeFigureOut">
              <a:rPr lang="en-US" smtClean="0"/>
              <a:t>1/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0880-44C6-4194-8F38-8C5D571D1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948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8808" y="3039535"/>
            <a:ext cx="18693944" cy="5071532"/>
          </a:xfrm>
        </p:spPr>
        <p:txBody>
          <a:bodyPr anchor="b"/>
          <a:lstStyle>
            <a:lvl1pPr>
              <a:defRPr sz="10666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8808" y="8159046"/>
            <a:ext cx="18693944" cy="2666999"/>
          </a:xfrm>
        </p:spPr>
        <p:txBody>
          <a:bodyPr/>
          <a:lstStyle>
            <a:lvl1pPr marL="0" indent="0">
              <a:buNone/>
              <a:defRPr sz="4266">
                <a:solidFill>
                  <a:schemeClr val="tx1">
                    <a:tint val="82000"/>
                  </a:schemeClr>
                </a:solidFill>
              </a:defRPr>
            </a:lvl1pPr>
            <a:lvl2pPr marL="812764" indent="0">
              <a:buNone/>
              <a:defRPr sz="3555">
                <a:solidFill>
                  <a:schemeClr val="tx1">
                    <a:tint val="82000"/>
                  </a:schemeClr>
                </a:solidFill>
              </a:defRPr>
            </a:lvl2pPr>
            <a:lvl3pPr marL="1625529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3pPr>
            <a:lvl4pPr marL="2438293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4pPr>
            <a:lvl5pPr marL="3251058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5pPr>
            <a:lvl6pPr marL="4063822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6pPr>
            <a:lvl7pPr marL="4876587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7pPr>
            <a:lvl8pPr marL="568935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8pPr>
            <a:lvl9pPr marL="6502116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96160-37B1-4440-BB8A-D07BCDAEAA14}" type="datetimeFigureOut">
              <a:rPr lang="en-US" smtClean="0"/>
              <a:t>1/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0880-44C6-4194-8F38-8C5D571D1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66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90097" y="3245556"/>
            <a:ext cx="9211509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72532" y="3245556"/>
            <a:ext cx="9211509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96160-37B1-4440-BB8A-D07BCDAEAA14}" type="datetimeFigureOut">
              <a:rPr lang="en-US" smtClean="0"/>
              <a:t>1/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0880-44C6-4194-8F38-8C5D571D1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820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92920" y="649112"/>
            <a:ext cx="18693944" cy="235655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92921" y="2988734"/>
            <a:ext cx="9169175" cy="1464732"/>
          </a:xfrm>
        </p:spPr>
        <p:txBody>
          <a:bodyPr anchor="b"/>
          <a:lstStyle>
            <a:lvl1pPr marL="0" indent="0">
              <a:buNone/>
              <a:defRPr sz="4266" b="1"/>
            </a:lvl1pPr>
            <a:lvl2pPr marL="812764" indent="0">
              <a:buNone/>
              <a:defRPr sz="3555" b="1"/>
            </a:lvl2pPr>
            <a:lvl3pPr marL="1625529" indent="0">
              <a:buNone/>
              <a:defRPr sz="3200" b="1"/>
            </a:lvl3pPr>
            <a:lvl4pPr marL="2438293" indent="0">
              <a:buNone/>
              <a:defRPr sz="2844" b="1"/>
            </a:lvl4pPr>
            <a:lvl5pPr marL="3251058" indent="0">
              <a:buNone/>
              <a:defRPr sz="2844" b="1"/>
            </a:lvl5pPr>
            <a:lvl6pPr marL="4063822" indent="0">
              <a:buNone/>
              <a:defRPr sz="2844" b="1"/>
            </a:lvl6pPr>
            <a:lvl7pPr marL="4876587" indent="0">
              <a:buNone/>
              <a:defRPr sz="2844" b="1"/>
            </a:lvl7pPr>
            <a:lvl8pPr marL="5689351" indent="0">
              <a:buNone/>
              <a:defRPr sz="2844" b="1"/>
            </a:lvl8pPr>
            <a:lvl9pPr marL="6502116" indent="0">
              <a:buNone/>
              <a:defRPr sz="2844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92921" y="4453467"/>
            <a:ext cx="9169175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72532" y="2988734"/>
            <a:ext cx="9214332" cy="1464732"/>
          </a:xfrm>
        </p:spPr>
        <p:txBody>
          <a:bodyPr anchor="b"/>
          <a:lstStyle>
            <a:lvl1pPr marL="0" indent="0">
              <a:buNone/>
              <a:defRPr sz="4266" b="1"/>
            </a:lvl1pPr>
            <a:lvl2pPr marL="812764" indent="0">
              <a:buNone/>
              <a:defRPr sz="3555" b="1"/>
            </a:lvl2pPr>
            <a:lvl3pPr marL="1625529" indent="0">
              <a:buNone/>
              <a:defRPr sz="3200" b="1"/>
            </a:lvl3pPr>
            <a:lvl4pPr marL="2438293" indent="0">
              <a:buNone/>
              <a:defRPr sz="2844" b="1"/>
            </a:lvl4pPr>
            <a:lvl5pPr marL="3251058" indent="0">
              <a:buNone/>
              <a:defRPr sz="2844" b="1"/>
            </a:lvl5pPr>
            <a:lvl6pPr marL="4063822" indent="0">
              <a:buNone/>
              <a:defRPr sz="2844" b="1"/>
            </a:lvl6pPr>
            <a:lvl7pPr marL="4876587" indent="0">
              <a:buNone/>
              <a:defRPr sz="2844" b="1"/>
            </a:lvl7pPr>
            <a:lvl8pPr marL="5689351" indent="0">
              <a:buNone/>
              <a:defRPr sz="2844" b="1"/>
            </a:lvl8pPr>
            <a:lvl9pPr marL="6502116" indent="0">
              <a:buNone/>
              <a:defRPr sz="2844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72532" y="4453467"/>
            <a:ext cx="9214332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96160-37B1-4440-BB8A-D07BCDAEAA14}" type="datetimeFigureOut">
              <a:rPr lang="en-US" smtClean="0"/>
              <a:t>1/1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0880-44C6-4194-8F38-8C5D571D1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448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96160-37B1-4440-BB8A-D07BCDAEAA14}" type="datetimeFigureOut">
              <a:rPr lang="en-US" smtClean="0"/>
              <a:t>1/1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0880-44C6-4194-8F38-8C5D571D1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788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96160-37B1-4440-BB8A-D07BCDAEAA14}" type="datetimeFigureOut">
              <a:rPr lang="en-US" smtClean="0"/>
              <a:t>1/1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0880-44C6-4194-8F38-8C5D571D1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9094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92921" y="812800"/>
            <a:ext cx="699047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214332" y="1755423"/>
            <a:ext cx="10972532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6"/>
            </a:lvl3pPr>
            <a:lvl4pPr>
              <a:defRPr sz="3555"/>
            </a:lvl4pPr>
            <a:lvl5pPr>
              <a:defRPr sz="3555"/>
            </a:lvl5pPr>
            <a:lvl6pPr>
              <a:defRPr sz="3555"/>
            </a:lvl6pPr>
            <a:lvl7pPr>
              <a:defRPr sz="3555"/>
            </a:lvl7pPr>
            <a:lvl8pPr>
              <a:defRPr sz="3555"/>
            </a:lvl8pPr>
            <a:lvl9pPr>
              <a:defRPr sz="355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92921" y="3657600"/>
            <a:ext cx="699047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764" indent="0">
              <a:buNone/>
              <a:defRPr sz="2489"/>
            </a:lvl2pPr>
            <a:lvl3pPr marL="1625529" indent="0">
              <a:buNone/>
              <a:defRPr sz="2133"/>
            </a:lvl3pPr>
            <a:lvl4pPr marL="2438293" indent="0">
              <a:buNone/>
              <a:defRPr sz="1778"/>
            </a:lvl4pPr>
            <a:lvl5pPr marL="3251058" indent="0">
              <a:buNone/>
              <a:defRPr sz="1778"/>
            </a:lvl5pPr>
            <a:lvl6pPr marL="4063822" indent="0">
              <a:buNone/>
              <a:defRPr sz="1778"/>
            </a:lvl6pPr>
            <a:lvl7pPr marL="4876587" indent="0">
              <a:buNone/>
              <a:defRPr sz="1778"/>
            </a:lvl7pPr>
            <a:lvl8pPr marL="5689351" indent="0">
              <a:buNone/>
              <a:defRPr sz="1778"/>
            </a:lvl8pPr>
            <a:lvl9pPr marL="6502116" indent="0">
              <a:buNone/>
              <a:defRPr sz="177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96160-37B1-4440-BB8A-D07BCDAEAA14}" type="datetimeFigureOut">
              <a:rPr lang="en-US" smtClean="0"/>
              <a:t>1/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0880-44C6-4194-8F38-8C5D571D1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7004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92921" y="812800"/>
            <a:ext cx="699047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214332" y="1755423"/>
            <a:ext cx="10972532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764" indent="0">
              <a:buNone/>
              <a:defRPr sz="4978"/>
            </a:lvl2pPr>
            <a:lvl3pPr marL="1625529" indent="0">
              <a:buNone/>
              <a:defRPr sz="4266"/>
            </a:lvl3pPr>
            <a:lvl4pPr marL="2438293" indent="0">
              <a:buNone/>
              <a:defRPr sz="3555"/>
            </a:lvl4pPr>
            <a:lvl5pPr marL="3251058" indent="0">
              <a:buNone/>
              <a:defRPr sz="3555"/>
            </a:lvl5pPr>
            <a:lvl6pPr marL="4063822" indent="0">
              <a:buNone/>
              <a:defRPr sz="3555"/>
            </a:lvl6pPr>
            <a:lvl7pPr marL="4876587" indent="0">
              <a:buNone/>
              <a:defRPr sz="3555"/>
            </a:lvl7pPr>
            <a:lvl8pPr marL="5689351" indent="0">
              <a:buNone/>
              <a:defRPr sz="3555"/>
            </a:lvl8pPr>
            <a:lvl9pPr marL="6502116" indent="0">
              <a:buNone/>
              <a:defRPr sz="3555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92921" y="3657600"/>
            <a:ext cx="699047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764" indent="0">
              <a:buNone/>
              <a:defRPr sz="2489"/>
            </a:lvl2pPr>
            <a:lvl3pPr marL="1625529" indent="0">
              <a:buNone/>
              <a:defRPr sz="2133"/>
            </a:lvl3pPr>
            <a:lvl4pPr marL="2438293" indent="0">
              <a:buNone/>
              <a:defRPr sz="1778"/>
            </a:lvl4pPr>
            <a:lvl5pPr marL="3251058" indent="0">
              <a:buNone/>
              <a:defRPr sz="1778"/>
            </a:lvl5pPr>
            <a:lvl6pPr marL="4063822" indent="0">
              <a:buNone/>
              <a:defRPr sz="1778"/>
            </a:lvl6pPr>
            <a:lvl7pPr marL="4876587" indent="0">
              <a:buNone/>
              <a:defRPr sz="1778"/>
            </a:lvl7pPr>
            <a:lvl8pPr marL="5689351" indent="0">
              <a:buNone/>
              <a:defRPr sz="1778"/>
            </a:lvl8pPr>
            <a:lvl9pPr marL="6502116" indent="0">
              <a:buNone/>
              <a:defRPr sz="177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96160-37B1-4440-BB8A-D07BCDAEAA14}" type="datetimeFigureOut">
              <a:rPr lang="en-US" smtClean="0"/>
              <a:t>1/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40880-44C6-4194-8F38-8C5D571D1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866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90097" y="649112"/>
            <a:ext cx="18693944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90097" y="3245556"/>
            <a:ext cx="18693944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90097" y="11300179"/>
            <a:ext cx="4876681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3296160-37B1-4440-BB8A-D07BCDAEAA14}" type="datetimeFigureOut">
              <a:rPr lang="en-US" smtClean="0"/>
              <a:t>1/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79558" y="11300179"/>
            <a:ext cx="7315022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307360" y="11300179"/>
            <a:ext cx="4876681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AD40880-44C6-4194-8F38-8C5D571D1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775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25529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382" indent="-406382" algn="l" defTabSz="1625529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147" indent="-406382" algn="l" defTabSz="1625529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6" kern="1200">
          <a:solidFill>
            <a:schemeClr val="tx1"/>
          </a:solidFill>
          <a:latin typeface="+mn-lt"/>
          <a:ea typeface="+mn-ea"/>
          <a:cs typeface="+mn-cs"/>
        </a:defRPr>
      </a:lvl2pPr>
      <a:lvl3pPr marL="2031911" indent="-406382" algn="l" defTabSz="1625529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5" kern="1200">
          <a:solidFill>
            <a:schemeClr val="tx1"/>
          </a:solidFill>
          <a:latin typeface="+mn-lt"/>
          <a:ea typeface="+mn-ea"/>
          <a:cs typeface="+mn-cs"/>
        </a:defRPr>
      </a:lvl3pPr>
      <a:lvl4pPr marL="2844676" indent="-406382" algn="l" defTabSz="1625529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440" indent="-406382" algn="l" defTabSz="1625529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204" indent="-406382" algn="l" defTabSz="1625529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2969" indent="-406382" algn="l" defTabSz="1625529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5733" indent="-406382" algn="l" defTabSz="1625529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498" indent="-406382" algn="l" defTabSz="1625529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52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764" algn="l" defTabSz="162552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529" algn="l" defTabSz="162552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293" algn="l" defTabSz="162552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058" algn="l" defTabSz="162552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3822" algn="l" defTabSz="162552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587" algn="l" defTabSz="162552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351" algn="l" defTabSz="162552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116" algn="l" defTabSz="1625529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oleObject" Target="../embeddings/oleObject3.bin"/><Relationship Id="rId18" Type="http://schemas.openxmlformats.org/officeDocument/2006/relationships/image" Target="../media/image16.emf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12" Type="http://schemas.openxmlformats.org/officeDocument/2006/relationships/image" Target="../media/image13.png"/><Relationship Id="rId17" Type="http://schemas.openxmlformats.org/officeDocument/2006/relationships/oleObject" Target="../embeddings/oleObject5.bin"/><Relationship Id="rId2" Type="http://schemas.openxmlformats.org/officeDocument/2006/relationships/image" Target="../media/image3.png"/><Relationship Id="rId16" Type="http://schemas.openxmlformats.org/officeDocument/2006/relationships/image" Target="../media/image15.emf"/><Relationship Id="rId20" Type="http://schemas.openxmlformats.org/officeDocument/2006/relationships/image" Target="../media/image1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5" Type="http://schemas.openxmlformats.org/officeDocument/2006/relationships/oleObject" Target="../embeddings/oleObject4.bin"/><Relationship Id="rId10" Type="http://schemas.openxmlformats.org/officeDocument/2006/relationships/image" Target="../media/image11.png"/><Relationship Id="rId19" Type="http://schemas.openxmlformats.org/officeDocument/2006/relationships/oleObject" Target="../embeddings/oleObject6.bin"/><Relationship Id="rId4" Type="http://schemas.openxmlformats.org/officeDocument/2006/relationships/image" Target="../media/image5.png"/><Relationship Id="rId9" Type="http://schemas.openxmlformats.org/officeDocument/2006/relationships/image" Target="../media/image10.png"/><Relationship Id="rId14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직사각형 12"/>
          <p:cNvSpPr/>
          <p:nvPr/>
        </p:nvSpPr>
        <p:spPr>
          <a:xfrm>
            <a:off x="0" y="2344140"/>
            <a:ext cx="21674138" cy="74066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aphicFrame>
        <p:nvGraphicFramePr>
          <p:cNvPr id="18" name="개체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8834273"/>
              </p:ext>
            </p:extLst>
          </p:nvPr>
        </p:nvGraphicFramePr>
        <p:xfrm>
          <a:off x="10820109" y="2989482"/>
          <a:ext cx="12041433" cy="67612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9550079" imgH="5362334" progId="Prism10.Document">
                  <p:embed/>
                </p:oleObj>
              </mc:Choice>
              <mc:Fallback>
                <p:oleObj name="Prism 10" r:id="rId2" imgW="9550079" imgH="536233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820109" y="2989482"/>
                        <a:ext cx="12041433" cy="67612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53CA09F-D774-923B-FFC3-E670CF6B8C64}"/>
              </a:ext>
            </a:extLst>
          </p:cNvPr>
          <p:cNvSpPr txBox="1"/>
          <p:nvPr/>
        </p:nvSpPr>
        <p:spPr>
          <a:xfrm>
            <a:off x="164393" y="35816"/>
            <a:ext cx="21509746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Optimization of PBM parameters for </a:t>
            </a:r>
            <a:r>
              <a:rPr lang="en-US" altLang="ko-KR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hMSC</a:t>
            </a: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 spheroid–mediated neuroprotection under oxidative stress. 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(A–B)</a:t>
            </a: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Cell viability of primary rat cortical neurons was assessed using an MTT assay 24 h after hydrogen peroxide (H₂O₂)–induced oxidative stress and subsequent co-culture with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hMSC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 spheroids. Cortical neurons were exposed to low (10 µM; A) or high (100 µM; B) concentrations of H₂O₂ for 30 min, followed by co-culture with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hMSC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 spheroids. Prior to co-culture,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hMSC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 spheroids were preconditioned by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photobiomodulation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 (PBM) using either 660 nm light at 5, 10, or 20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/cm² or 850 nm light at 6, 12, or 24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/cm² for 10 min. Cell viability is expressed as a percentage relative to untreated control neurons. Data are presented as mean ± SEM. Statistical significance was determined by one-way ANOVA followed by post hoc analysis (*p &lt; 0.05, ***p &lt; 0.001, ****p &lt; 0.0001).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807E129-3CE3-F61C-3F8B-99F14D6786F1}"/>
              </a:ext>
            </a:extLst>
          </p:cNvPr>
          <p:cNvSpPr txBox="1"/>
          <p:nvPr/>
        </p:nvSpPr>
        <p:spPr>
          <a:xfrm>
            <a:off x="678566" y="2666317"/>
            <a:ext cx="120260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altLang="ko-KR" sz="3600" b="1" dirty="0">
                <a:latin typeface="Times New Roman"/>
                <a:cs typeface="Times New Roman"/>
              </a:rPr>
              <a:t>(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807E129-3CE3-F61C-3F8B-99F14D6786F1}"/>
              </a:ext>
            </a:extLst>
          </p:cNvPr>
          <p:cNvSpPr txBox="1"/>
          <p:nvPr/>
        </p:nvSpPr>
        <p:spPr>
          <a:xfrm>
            <a:off x="10218806" y="2666317"/>
            <a:ext cx="120260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altLang="ko-KR" sz="3600" b="1" dirty="0">
                <a:latin typeface="Times New Roman"/>
                <a:cs typeface="Times New Roman"/>
              </a:rPr>
              <a:t>(B)</a:t>
            </a:r>
          </a:p>
        </p:txBody>
      </p:sp>
      <p:graphicFrame>
        <p:nvGraphicFramePr>
          <p:cNvPr id="15" name="개체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6120166"/>
              </p:ext>
            </p:extLst>
          </p:nvPr>
        </p:nvGraphicFramePr>
        <p:xfrm>
          <a:off x="267264" y="2989482"/>
          <a:ext cx="11201315" cy="67612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9487415" imgH="5362334" progId="Prism10.Document">
                  <p:embed/>
                </p:oleObj>
              </mc:Choice>
              <mc:Fallback>
                <p:oleObj name="Prism 10" r:id="rId4" imgW="9487415" imgH="536233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7264" y="2989482"/>
                        <a:ext cx="11201315" cy="67612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297628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직사각형 34"/>
          <p:cNvSpPr/>
          <p:nvPr/>
        </p:nvSpPr>
        <p:spPr>
          <a:xfrm>
            <a:off x="0" y="4500380"/>
            <a:ext cx="21674138" cy="2115239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23" name="그림 2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73955" y="5191171"/>
            <a:ext cx="3531380" cy="3531380"/>
          </a:xfrm>
          <a:prstGeom prst="rect">
            <a:avLst/>
          </a:prstGeom>
        </p:spPr>
      </p:pic>
      <p:pic>
        <p:nvPicPr>
          <p:cNvPr id="24" name="그림 2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63553" y="5191171"/>
            <a:ext cx="3531380" cy="3531380"/>
          </a:xfrm>
          <a:prstGeom prst="rect">
            <a:avLst/>
          </a:prstGeom>
        </p:spPr>
      </p:pic>
      <p:pic>
        <p:nvPicPr>
          <p:cNvPr id="25" name="그림 2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84361" y="5191171"/>
            <a:ext cx="3531380" cy="3531380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4760" y="5191172"/>
            <a:ext cx="3531380" cy="3531379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553159" y="5191173"/>
            <a:ext cx="3531380" cy="353138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142758" y="5191171"/>
            <a:ext cx="3531380" cy="3531380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73444" y="8805983"/>
            <a:ext cx="3531380" cy="3531380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373961" y="8805983"/>
            <a:ext cx="3531380" cy="3531380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963559" y="8805983"/>
            <a:ext cx="3531380" cy="353138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8A883031-6A5E-D317-400F-1B173E43B829}"/>
              </a:ext>
            </a:extLst>
          </p:cNvPr>
          <p:cNvSpPr txBox="1"/>
          <p:nvPr/>
        </p:nvSpPr>
        <p:spPr>
          <a:xfrm>
            <a:off x="159204" y="5161532"/>
            <a:ext cx="15324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A883031-6A5E-D317-400F-1B173E43B829}"/>
              </a:ext>
            </a:extLst>
          </p:cNvPr>
          <p:cNvSpPr txBox="1"/>
          <p:nvPr/>
        </p:nvSpPr>
        <p:spPr>
          <a:xfrm>
            <a:off x="3748805" y="5161533"/>
            <a:ext cx="15324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0</a:t>
            </a:r>
            <a:r>
              <a:rPr lang="el-GR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1600" b="1" spc="-89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A883031-6A5E-D317-400F-1B173E43B829}"/>
              </a:ext>
            </a:extLst>
          </p:cNvPr>
          <p:cNvSpPr txBox="1"/>
          <p:nvPr/>
        </p:nvSpPr>
        <p:spPr>
          <a:xfrm>
            <a:off x="3748805" y="8785978"/>
            <a:ext cx="15324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00</a:t>
            </a:r>
            <a:r>
              <a:rPr lang="el-GR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ko-KR" altLang="en-US" sz="1600" b="1" spc="-89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A883031-6A5E-D317-400F-1B173E43B829}"/>
              </a:ext>
            </a:extLst>
          </p:cNvPr>
          <p:cNvSpPr txBox="1"/>
          <p:nvPr/>
        </p:nvSpPr>
        <p:spPr>
          <a:xfrm>
            <a:off x="7338403" y="5161533"/>
            <a:ext cx="36583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0</a:t>
            </a:r>
            <a:r>
              <a:rPr lang="el-GR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+ SP + 660 nm</a:t>
            </a:r>
            <a:endParaRPr lang="ko-KR" altLang="en-US" sz="1600" b="1" spc="-89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A883031-6A5E-D317-400F-1B173E43B829}"/>
              </a:ext>
            </a:extLst>
          </p:cNvPr>
          <p:cNvSpPr txBox="1"/>
          <p:nvPr/>
        </p:nvSpPr>
        <p:spPr>
          <a:xfrm>
            <a:off x="7338403" y="8785978"/>
            <a:ext cx="36583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00</a:t>
            </a:r>
            <a:r>
              <a:rPr lang="el-GR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+ SP + 660 nm</a:t>
            </a:r>
            <a:endParaRPr lang="ko-KR" altLang="en-US" sz="1600" b="1" spc="-89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A883031-6A5E-D317-400F-1B173E43B829}"/>
              </a:ext>
            </a:extLst>
          </p:cNvPr>
          <p:cNvSpPr txBox="1"/>
          <p:nvPr/>
        </p:nvSpPr>
        <p:spPr>
          <a:xfrm>
            <a:off x="10928003" y="5161533"/>
            <a:ext cx="36583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0</a:t>
            </a:r>
            <a:r>
              <a:rPr lang="el-GR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+ SP + 660 nm (</a:t>
            </a:r>
            <a:r>
              <a:rPr lang="en-US" altLang="ko-KR" sz="1600" b="1" spc="-89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well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spc="-89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A883031-6A5E-D317-400F-1B173E43B829}"/>
              </a:ext>
            </a:extLst>
          </p:cNvPr>
          <p:cNvSpPr txBox="1"/>
          <p:nvPr/>
        </p:nvSpPr>
        <p:spPr>
          <a:xfrm>
            <a:off x="10928003" y="8785978"/>
            <a:ext cx="36583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00</a:t>
            </a:r>
            <a:r>
              <a:rPr lang="el-GR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+ SP + 660 nm (</a:t>
            </a:r>
            <a:r>
              <a:rPr lang="en-US" altLang="ko-KR" sz="1600" b="1" spc="-89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well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spc="-89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그림 1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4553160" y="8815614"/>
            <a:ext cx="3531380" cy="3531380"/>
          </a:xfrm>
          <a:prstGeom prst="rect">
            <a:avLst/>
          </a:prstGeom>
        </p:spPr>
      </p:pic>
      <p:pic>
        <p:nvPicPr>
          <p:cNvPr id="22" name="그림 2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8142758" y="8815614"/>
            <a:ext cx="3531380" cy="353138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8A883031-6A5E-D317-400F-1B173E43B829}"/>
              </a:ext>
            </a:extLst>
          </p:cNvPr>
          <p:cNvSpPr txBox="1"/>
          <p:nvPr/>
        </p:nvSpPr>
        <p:spPr>
          <a:xfrm>
            <a:off x="14517604" y="5171167"/>
            <a:ext cx="36583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0</a:t>
            </a:r>
            <a:r>
              <a:rPr lang="el-GR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+ SP + 850 nm</a:t>
            </a:r>
            <a:endParaRPr lang="ko-KR" altLang="en-US" sz="1600" b="1" spc="-89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A883031-6A5E-D317-400F-1B173E43B829}"/>
              </a:ext>
            </a:extLst>
          </p:cNvPr>
          <p:cNvSpPr txBox="1"/>
          <p:nvPr/>
        </p:nvSpPr>
        <p:spPr>
          <a:xfrm>
            <a:off x="18107202" y="5171167"/>
            <a:ext cx="36583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0</a:t>
            </a:r>
            <a:r>
              <a:rPr lang="el-GR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+ SP + 850 nm (</a:t>
            </a:r>
            <a:r>
              <a:rPr lang="en-US" altLang="ko-KR" sz="1600" b="1" spc="-89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well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spc="-89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A883031-6A5E-D317-400F-1B173E43B829}"/>
              </a:ext>
            </a:extLst>
          </p:cNvPr>
          <p:cNvSpPr txBox="1"/>
          <p:nvPr/>
        </p:nvSpPr>
        <p:spPr>
          <a:xfrm>
            <a:off x="14517603" y="8785978"/>
            <a:ext cx="36583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00</a:t>
            </a:r>
            <a:r>
              <a:rPr lang="el-GR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+ SP + 850 nm</a:t>
            </a:r>
            <a:endParaRPr lang="ko-KR" altLang="en-US" sz="1600" b="1" spc="-89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A883031-6A5E-D317-400F-1B173E43B829}"/>
              </a:ext>
            </a:extLst>
          </p:cNvPr>
          <p:cNvSpPr txBox="1"/>
          <p:nvPr/>
        </p:nvSpPr>
        <p:spPr>
          <a:xfrm>
            <a:off x="18107202" y="8785978"/>
            <a:ext cx="36583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ko-KR" sz="1600" b="1" spc="-89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00</a:t>
            </a:r>
            <a:r>
              <a:rPr lang="el-GR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+ SP + 850 nm (</a:t>
            </a:r>
            <a:r>
              <a:rPr lang="en-US" altLang="ko-KR" sz="1600" b="1" spc="-89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well</a:t>
            </a:r>
            <a:r>
              <a:rPr lang="en-US" altLang="ko-KR" sz="1600" b="1" spc="-89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spc="-89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그룹 11"/>
          <p:cNvGrpSpPr/>
          <p:nvPr/>
        </p:nvGrpSpPr>
        <p:grpSpPr>
          <a:xfrm>
            <a:off x="1691675" y="12560196"/>
            <a:ext cx="20414041" cy="13092575"/>
            <a:chOff x="1691675" y="7633825"/>
            <a:chExt cx="18425701" cy="11817350"/>
          </a:xfrm>
        </p:grpSpPr>
        <p:graphicFrame>
          <p:nvGraphicFramePr>
            <p:cNvPr id="2" name="개체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52203790"/>
                </p:ext>
              </p:extLst>
            </p:nvPr>
          </p:nvGraphicFramePr>
          <p:xfrm>
            <a:off x="1691675" y="7873537"/>
            <a:ext cx="9537700" cy="56689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3" imgW="9537834" imgH="5668825" progId="Prism10.Document">
                    <p:embed/>
                  </p:oleObj>
                </mc:Choice>
                <mc:Fallback>
                  <p:oleObj name="Prism 10" r:id="rId13" imgW="9537834" imgH="5668825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691675" y="7873537"/>
                          <a:ext cx="9537700" cy="56689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개체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3666088"/>
                </p:ext>
              </p:extLst>
            </p:nvPr>
          </p:nvGraphicFramePr>
          <p:xfrm>
            <a:off x="10687626" y="7633825"/>
            <a:ext cx="9429750" cy="59086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5" imgW="9429433" imgH="5909407" progId="Prism10.Document">
                    <p:embed/>
                  </p:oleObj>
                </mc:Choice>
                <mc:Fallback>
                  <p:oleObj name="Prism 10" r:id="rId15" imgW="9429433" imgH="5909407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0687626" y="7633825"/>
                          <a:ext cx="9429750" cy="59086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개체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6400533"/>
                </p:ext>
              </p:extLst>
            </p:nvPr>
          </p:nvGraphicFramePr>
          <p:xfrm>
            <a:off x="1691675" y="13782212"/>
            <a:ext cx="9537700" cy="56689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7" imgW="9537834" imgH="5668825" progId="Prism10.Document">
                    <p:embed/>
                  </p:oleObj>
                </mc:Choice>
                <mc:Fallback>
                  <p:oleObj name="Prism 10" r:id="rId17" imgW="9537834" imgH="5668825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1691675" y="13782212"/>
                          <a:ext cx="9537700" cy="56689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개체 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1240817"/>
                </p:ext>
              </p:extLst>
            </p:nvPr>
          </p:nvGraphicFramePr>
          <p:xfrm>
            <a:off x="10687626" y="13782212"/>
            <a:ext cx="9429750" cy="56689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9" imgW="9429433" imgH="5668825" progId="Prism10.Document">
                    <p:embed/>
                  </p:oleObj>
                </mc:Choice>
                <mc:Fallback>
                  <p:oleObj name="Prism 10" r:id="rId19" imgW="9429433" imgH="5668825" progId="Prism10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10687626" y="13782212"/>
                          <a:ext cx="9429750" cy="56689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5807E129-3CE3-F61C-3F8B-99F14D6786F1}"/>
              </a:ext>
            </a:extLst>
          </p:cNvPr>
          <p:cNvSpPr txBox="1"/>
          <p:nvPr/>
        </p:nvSpPr>
        <p:spPr>
          <a:xfrm>
            <a:off x="0" y="4500381"/>
            <a:ext cx="120260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altLang="ko-KR" sz="3600" b="1" dirty="0">
                <a:latin typeface="Times New Roman"/>
                <a:cs typeface="Times New Roman"/>
              </a:rPr>
              <a:t>(A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807E129-3CE3-F61C-3F8B-99F14D6786F1}"/>
              </a:ext>
            </a:extLst>
          </p:cNvPr>
          <p:cNvSpPr txBox="1"/>
          <p:nvPr/>
        </p:nvSpPr>
        <p:spPr>
          <a:xfrm>
            <a:off x="1359146" y="12560196"/>
            <a:ext cx="120260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altLang="ko-KR" sz="3600" b="1" dirty="0">
                <a:latin typeface="Times New Roman"/>
                <a:cs typeface="Times New Roman"/>
              </a:rPr>
              <a:t>(B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807E129-3CE3-F61C-3F8B-99F14D6786F1}"/>
              </a:ext>
            </a:extLst>
          </p:cNvPr>
          <p:cNvSpPr txBox="1"/>
          <p:nvPr/>
        </p:nvSpPr>
        <p:spPr>
          <a:xfrm>
            <a:off x="10996781" y="12560196"/>
            <a:ext cx="120260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altLang="ko-KR" sz="3600" b="1" dirty="0">
                <a:latin typeface="Times New Roman"/>
                <a:cs typeface="Times New Roman"/>
              </a:rPr>
              <a:t>(C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807E129-3CE3-F61C-3F8B-99F14D6786F1}"/>
              </a:ext>
            </a:extLst>
          </p:cNvPr>
          <p:cNvSpPr txBox="1"/>
          <p:nvPr/>
        </p:nvSpPr>
        <p:spPr>
          <a:xfrm>
            <a:off x="1359146" y="19270310"/>
            <a:ext cx="120260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altLang="ko-KR" sz="3600" b="1" dirty="0">
                <a:latin typeface="Times New Roman"/>
                <a:cs typeface="Times New Roman"/>
              </a:rPr>
              <a:t>(D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807E129-3CE3-F61C-3F8B-99F14D6786F1}"/>
              </a:ext>
            </a:extLst>
          </p:cNvPr>
          <p:cNvSpPr txBox="1"/>
          <p:nvPr/>
        </p:nvSpPr>
        <p:spPr>
          <a:xfrm>
            <a:off x="10996781" y="19270310"/>
            <a:ext cx="120260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altLang="ko-KR" sz="3600" b="1" dirty="0">
                <a:latin typeface="Times New Roman"/>
                <a:cs typeface="Times New Roman"/>
              </a:rPr>
              <a:t>(E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53CA09F-D774-923B-FFC3-E670CF6B8C64}"/>
              </a:ext>
            </a:extLst>
          </p:cNvPr>
          <p:cNvSpPr txBox="1"/>
          <p:nvPr/>
        </p:nvSpPr>
        <p:spPr>
          <a:xfrm>
            <a:off x="164393" y="0"/>
            <a:ext cx="21509746" cy="41549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Comparison of direct and </a:t>
            </a:r>
            <a:r>
              <a:rPr lang="en-US" altLang="ko-KR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transwell</a:t>
            </a: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 co-culture reveals a paracrine-mediated effect of PBM-treated </a:t>
            </a:r>
            <a:r>
              <a:rPr lang="en-US" altLang="ko-KR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hMSC</a:t>
            </a: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 spheroids on neurite outgrowth. 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(A) Representative immunofluorescence images of primary rat cortical neurons stained for MAP2 (red) and DAPI (blue) 24 h after hydrogen peroxide (H₂O₂)–induced oxidative stress and co-culture with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hMSC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 spheroids. Neurons were exposed to 10 µM or 100 µM H₂O₂ for 30 min, followed by co-culture with PBM-treated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hMSC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 spheroids either directly placed onto neuronal cultures (direct co-culture) or physically separated using a 0.4 µm pore size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transwell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 insert, allowing only paracrine factor exchange.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hMSC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 spheroids were preconditioned with 660 nm (10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/cm²) or 850 nm (12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/cm²) PBM for 10 min prior to co-culture. Scale bar: 50 µm. (B, C) Quantification of total neurite outgrowth expressed as a percentage of control under low (10 µM; B) and high (100 µM; C) H₂O₂ conditions. Both direct and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transwell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 co-culture with PBM-treated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hMSC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 spheroids significantly restored neurite outgrowth compared to H₂O₂-treated neurons alone. (D, E) Quantification of neurite branch numbers under 10 µM (D) and 100 µM (E) H₂O₂ exposure. Increased branching was observed following co-culture with PBM-treated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hMSC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 spheroids, including under </a:t>
            </a:r>
            <a:r>
              <a:rPr lang="en-US" altLang="ko-KR" sz="2400" dirty="0" err="1">
                <a:latin typeface="arial" panose="020B0604020202020204" pitchFamily="34" charset="0"/>
                <a:cs typeface="arial" panose="020B0604020202020204" pitchFamily="34" charset="0"/>
              </a:rPr>
              <a:t>transwell</a:t>
            </a:r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 conditions, indicating that the neurite-promoting effect is predominantly mediated by paracrine signaling rather than direct cell–cell contact. Data are presented as mean ± SEM. Statistical significance was determined by one-way ANOVA followed by post hoc analysis (*p &lt; 0.05, **p &lt; 0.01, ***p &lt; 0.001, ****p &lt; 0.0001).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02545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문서" ma:contentTypeID="0x010100F7EB70862B11DF44B98A367713B80A7E" ma:contentTypeVersion="4" ma:contentTypeDescription="새 문서를 만듭니다." ma:contentTypeScope="" ma:versionID="c482f8d9e5a86e1b29b043b86c295821">
  <xsd:schema xmlns:xsd="http://www.w3.org/2001/XMLSchema" xmlns:xs="http://www.w3.org/2001/XMLSchema" xmlns:p="http://schemas.microsoft.com/office/2006/metadata/properties" xmlns:ns3="7cd29542-0691-48a4-ab61-0f5d99ed9235" targetNamespace="http://schemas.microsoft.com/office/2006/metadata/properties" ma:root="true" ma:fieldsID="b508cce391630a4cf47dcd2bc8f010d3" ns3:_="">
    <xsd:import namespace="7cd29542-0691-48a4-ab61-0f5d99ed9235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cd29542-0691-48a4-ab61-0f5d99ed923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콘텐츠 형식"/>
        <xsd:element ref="dc:title" minOccurs="0" maxOccurs="1" ma:index="4" ma:displayName="제목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C2CAD556-57C5-48B8-AE57-0202A78391E6}">
  <ds:schemaRefs>
    <ds:schemaRef ds:uri="http://purl.org/dc/dcmitype/"/>
    <ds:schemaRef ds:uri="http://schemas.microsoft.com/office/2006/documentManagement/types"/>
    <ds:schemaRef ds:uri="http://www.w3.org/XML/1998/namespace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7cd29542-0691-48a4-ab61-0f5d99ed9235"/>
    <ds:schemaRef ds:uri="http://schemas.microsoft.com/office/2006/metadata/properties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1CC02D49-F42A-4BF0-A3EC-004BC82D562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A5E7D9D-F524-4983-9E08-824CF19942B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cd29542-0691-48a4-ab61-0f5d99ed923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46</TotalTime>
  <Words>619</Words>
  <Application>Microsoft Macintosh PowerPoint</Application>
  <PresentationFormat>Custom</PresentationFormat>
  <Paragraphs>20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ptos</vt:lpstr>
      <vt:lpstr>Aptos Display</vt:lpstr>
      <vt:lpstr>Arial</vt:lpstr>
      <vt:lpstr>Arial</vt:lpstr>
      <vt:lpstr>Times New Roman</vt:lpstr>
      <vt:lpstr>Office 테마</vt:lpstr>
      <vt:lpstr>Prism 10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장소영(한국베크만광의료기기연구센터(천))</dc:creator>
  <cp:lastModifiedBy>Min Young Lee</cp:lastModifiedBy>
  <cp:revision>73</cp:revision>
  <dcterms:created xsi:type="dcterms:W3CDTF">2025-03-18T07:20:14Z</dcterms:created>
  <dcterms:modified xsi:type="dcterms:W3CDTF">2026-01-01T04:53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7EB70862B11DF44B98A367713B80A7E</vt:lpwstr>
  </property>
</Properties>
</file>